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9" userDrawn="1">
          <p15:clr>
            <a:srgbClr val="A4A3A4"/>
          </p15:clr>
        </p15:guide>
        <p15:guide id="2" pos="236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570E2D1-1DD8-4D3F-BD8A-D875BA105B5C}" v="1" dt="2024-06-10T16:59:18.2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720" y="72"/>
      </p:cViewPr>
      <p:guideLst>
        <p:guide orient="horz" pos="799"/>
        <p:guide pos="23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vier Sierra Isturiz" userId="d8b3d0ae-a242-4736-98fc-9ee2342b4e28" providerId="ADAL" clId="{B570E2D1-1DD8-4D3F-BD8A-D875BA105B5C}"/>
    <pc:docChg chg="modSld">
      <pc:chgData name="Javier Sierra Isturiz" userId="d8b3d0ae-a242-4736-98fc-9ee2342b4e28" providerId="ADAL" clId="{B570E2D1-1DD8-4D3F-BD8A-D875BA105B5C}" dt="2024-06-10T16:59:18.236" v="0" actId="164"/>
      <pc:docMkLst>
        <pc:docMk/>
      </pc:docMkLst>
      <pc:sldChg chg="addSp modSp">
        <pc:chgData name="Javier Sierra Isturiz" userId="d8b3d0ae-a242-4736-98fc-9ee2342b4e28" providerId="ADAL" clId="{B570E2D1-1DD8-4D3F-BD8A-D875BA105B5C}" dt="2024-06-10T16:59:18.236" v="0" actId="164"/>
        <pc:sldMkLst>
          <pc:docMk/>
          <pc:sldMk cId="4254670275" sldId="256"/>
        </pc:sldMkLst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7" creationId="{A43EB7A7-23A2-9B32-9EC0-1256C644FB9D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9" creationId="{5AE9F383-DDB2-4AC8-E681-32BDD5D1A014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10" creationId="{89D2E835-0E93-ED2A-53BA-BF9D47A12CBD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11" creationId="{82110865-A64A-ABF0-D74D-E100B072FA85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12" creationId="{DA514C56-3FC3-DF5F-4DC4-CBCDBFA482E4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13" creationId="{08313B8F-FFDA-5D0B-7258-A87A405CB333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29" creationId="{0FDD88F4-63AA-138A-A939-CEE73E4D74C6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30" creationId="{4D7E192E-3BD0-25F5-09C4-CA2C1C92290A}"/>
          </ac:spMkLst>
        </pc:spChg>
        <pc:spChg chg="mod">
          <ac:chgData name="Javier Sierra Isturiz" userId="d8b3d0ae-a242-4736-98fc-9ee2342b4e28" providerId="ADAL" clId="{B570E2D1-1DD8-4D3F-BD8A-D875BA105B5C}" dt="2024-06-10T16:59:18.236" v="0" actId="164"/>
          <ac:spMkLst>
            <pc:docMk/>
            <pc:sldMk cId="4254670275" sldId="256"/>
            <ac:spMk id="31" creationId="{922AD1A5-FEE0-2DBA-DEC1-58608EC3907F}"/>
          </ac:spMkLst>
        </pc:spChg>
        <pc:grpChg chg="add mod">
          <ac:chgData name="Javier Sierra Isturiz" userId="d8b3d0ae-a242-4736-98fc-9ee2342b4e28" providerId="ADAL" clId="{B570E2D1-1DD8-4D3F-BD8A-D875BA105B5C}" dt="2024-06-10T16:59:18.236" v="0" actId="164"/>
          <ac:grpSpMkLst>
            <pc:docMk/>
            <pc:sldMk cId="4254670275" sldId="256"/>
            <ac:grpSpMk id="2" creationId="{1A2CCF28-7C5E-868E-7224-E43B53C17BF5}"/>
          </ac:grpSpMkLst>
        </pc:grpChg>
        <pc:picChg chg="mod">
          <ac:chgData name="Javier Sierra Isturiz" userId="d8b3d0ae-a242-4736-98fc-9ee2342b4e28" providerId="ADAL" clId="{B570E2D1-1DD8-4D3F-BD8A-D875BA105B5C}" dt="2024-06-10T16:59:18.236" v="0" actId="164"/>
          <ac:picMkLst>
            <pc:docMk/>
            <pc:sldMk cId="4254670275" sldId="256"/>
            <ac:picMk id="5" creationId="{D6A8C208-9DB5-227D-3031-20310169C72D}"/>
          </ac:picMkLst>
        </pc:picChg>
        <pc:picChg chg="mod">
          <ac:chgData name="Javier Sierra Isturiz" userId="d8b3d0ae-a242-4736-98fc-9ee2342b4e28" providerId="ADAL" clId="{B570E2D1-1DD8-4D3F-BD8A-D875BA105B5C}" dt="2024-06-10T16:59:18.236" v="0" actId="164"/>
          <ac:picMkLst>
            <pc:docMk/>
            <pc:sldMk cId="4254670275" sldId="256"/>
            <ac:picMk id="6" creationId="{2AA38564-EBA2-2C72-ADF4-618D890D60EA}"/>
          </ac:picMkLst>
        </pc:picChg>
        <pc:picChg chg="mod">
          <ac:chgData name="Javier Sierra Isturiz" userId="d8b3d0ae-a242-4736-98fc-9ee2342b4e28" providerId="ADAL" clId="{B570E2D1-1DD8-4D3F-BD8A-D875BA105B5C}" dt="2024-06-10T16:59:18.236" v="0" actId="164"/>
          <ac:picMkLst>
            <pc:docMk/>
            <pc:sldMk cId="4254670275" sldId="256"/>
            <ac:picMk id="8" creationId="{CB2D5C5C-1040-D2F4-B16C-F27A2DA4FDE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F762CD7-EC37-1CAB-6AEB-0C13C9106E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A8F91C2-A6DE-C8A4-AFD1-D3C933BDD0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9B68411-6419-30A1-1052-146D1432B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2D1AEBB-23F8-C6F8-62F8-693EAB2B1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6683E09-8C64-28F2-9EDC-A15E9EC75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083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2B81B5D-1291-45D9-2C46-2629EE6B09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500DDEB-BA72-75A0-8333-2F539E0582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176BB53-1A1A-D41D-F549-88E5FDD5E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4BAF0B7-3802-301D-9D0C-0DBF4747E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F2ACE48-BB25-6B1D-0BE5-30493A1D0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6699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B0A4581-481C-1432-345B-7EA7D0711B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2ED5D6D-C3AB-E06B-64EE-905C0236E9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5C49157-22C4-C7FF-E23C-35C467E11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19F43A-46EB-E846-BF05-89E84FE8D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535466-3975-05DB-0E2D-3149709EC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5185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511435-A2B5-3126-37E3-6184DC720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AD9ED99-18B5-C1AE-5F3A-729FD9F610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757F8A9-3782-8CBD-5738-5E407A9D4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3AA7EB3-775F-C43A-0F2C-1E91A5767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58521A2-7884-D006-7B29-0A857154F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5565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8FD814A-3357-D224-5455-2811EAF74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068EDBC-B97D-04C9-E1BF-CB2D7E1210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878D30E-5EBD-DA57-8086-D8AF38397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548F43E-2906-8A96-0A1E-4AF40F860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C54D4EE-79C5-437E-46EE-AE0DCF586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360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888F438-E3F5-70CE-AA2B-87D0669881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80C2367-D7B0-4310-1CF6-0BA1DE0078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7C580C6-EF1E-FB70-116B-3DDA092A91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5BFB3CB-212C-B97D-CAB7-446CBE78E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50645BC-F0C2-CD9C-AD1F-C0FF52811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9AAA4CD-47AA-0717-6E2C-BF1E7E4E6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1390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4A0C17-612B-AA07-13FF-9250A3CFC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2037EDE-87E7-E170-26F3-CDE296C56A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3B0114A-41AD-563A-45B2-04060A0F83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4DEFC19-317C-31BB-44CA-7114DC6508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895F5A8-D4BC-3224-4A3A-0CB9C450D6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3E8F87C-C578-47E6-DB86-D66AC3A75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8F2E79D-CA95-0697-5D3F-F11957749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5AB0B93-799B-27DD-BFDB-17818F2EE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8450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73F8A3-BF78-0E79-C5B1-A827467C2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91F9791-ED35-812B-8E80-B37EB82AD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3EBFA568-124D-1B3C-8413-2DAFF4239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19982DB-3B5B-9A0D-7603-049591835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4059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8BE77B8-AE20-D748-00FD-E29E259D0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F3ACCFB-73F8-E9B4-A306-9AC483C5E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D65508C-C3C9-D2CB-1A8A-ACAE9E473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7098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1FD008-4D68-96CD-540A-941B2CEF0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61BC003-7FD0-DFF5-EF63-F614B9E4A3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2E5A750-F929-BB4F-4D54-AF85E48C4A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778ADD1-54C1-35E1-6906-FA28BE52A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8AB970A-142D-2B2A-B819-33CF68DF9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FEF2008-638C-9B99-66F3-F39F76A27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3272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97EB06-22CC-7135-F2BF-3633AB9C7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FEED9B1-5BBA-2080-9DCF-E295188487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8F98F8D-2A93-9AEB-24AA-664D2BD568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5DDA023-2142-1C98-F50E-B7FAF13BE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492AB53-D83C-DB41-C8E3-011B78394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EF54C7E-F2FA-14A3-5FDD-C06994423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955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BB95F6B-7190-AF7F-62B9-8FDB7E234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5327EC4-F27B-7637-B86F-F899F44397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49DFD16-348A-7C73-1C23-54064E0ACA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C1A0A-3C76-4B1A-BCD2-8FB25275169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0C3D389-84C4-ABE1-450E-1FB6025DB7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03CA31-29B5-A1B6-04A3-514BE9D27A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8C5EA-E025-4A84-8FE8-A61D174821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4826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1A2CCF28-7C5E-868E-7224-E43B53C17BF5}"/>
              </a:ext>
            </a:extLst>
          </p:cNvPr>
          <p:cNvGrpSpPr/>
          <p:nvPr/>
        </p:nvGrpSpPr>
        <p:grpSpPr>
          <a:xfrm>
            <a:off x="1382134" y="1794971"/>
            <a:ext cx="9398234" cy="3146389"/>
            <a:chOff x="1382134" y="1794971"/>
            <a:chExt cx="9398234" cy="3146389"/>
          </a:xfrm>
        </p:grpSpPr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2AA38564-EBA2-2C72-ADF4-618D890D60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00300" y="1821983"/>
              <a:ext cx="3125165" cy="3119377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CB2D5C5C-1040-D2F4-B16C-F27A2DA4FDE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53588" y="1827770"/>
              <a:ext cx="3026780" cy="3113590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D6A8C208-9DB5-227D-3031-20310169C72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78866" y="1821983"/>
              <a:ext cx="3125165" cy="3119377"/>
            </a:xfrm>
            <a:prstGeom prst="rect">
              <a:avLst/>
            </a:prstGeom>
          </p:spPr>
        </p:pic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0FDD88F4-63AA-138A-A939-CEE73E4D74C6}"/>
                </a:ext>
              </a:extLst>
            </p:cNvPr>
            <p:cNvSpPr txBox="1"/>
            <p:nvPr/>
          </p:nvSpPr>
          <p:spPr>
            <a:xfrm>
              <a:off x="1382134" y="180143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4D7E192E-3BD0-25F5-09C4-CA2C1C92290A}"/>
                </a:ext>
              </a:extLst>
            </p:cNvPr>
            <p:cNvSpPr txBox="1"/>
            <p:nvPr/>
          </p:nvSpPr>
          <p:spPr>
            <a:xfrm>
              <a:off x="4560846" y="180364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922AD1A5-FEE0-2DBA-DEC1-58608EC3907F}"/>
                </a:ext>
              </a:extLst>
            </p:cNvPr>
            <p:cNvSpPr txBox="1"/>
            <p:nvPr/>
          </p:nvSpPr>
          <p:spPr>
            <a:xfrm>
              <a:off x="7721479" y="179497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A43EB7A7-23A2-9B32-9EC0-1256C644FB9D}"/>
                </a:ext>
              </a:extLst>
            </p:cNvPr>
            <p:cNvSpPr txBox="1"/>
            <p:nvPr/>
          </p:nvSpPr>
          <p:spPr>
            <a:xfrm>
              <a:off x="2456700" y="4604282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5AE9F383-DDB2-4AC8-E681-32BDD5D1A014}"/>
                </a:ext>
              </a:extLst>
            </p:cNvPr>
            <p:cNvSpPr txBox="1"/>
            <p:nvPr/>
          </p:nvSpPr>
          <p:spPr>
            <a:xfrm>
              <a:off x="2386052" y="4595977"/>
              <a:ext cx="23115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3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89D2E835-0E93-ED2A-53BA-BF9D47A12CBD}"/>
                </a:ext>
              </a:extLst>
            </p:cNvPr>
            <p:cNvSpPr txBox="1"/>
            <p:nvPr/>
          </p:nvSpPr>
          <p:spPr>
            <a:xfrm>
              <a:off x="5424202" y="4610593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82110865-A64A-ABF0-D74D-E100B072FA85}"/>
                </a:ext>
              </a:extLst>
            </p:cNvPr>
            <p:cNvSpPr txBox="1"/>
            <p:nvPr/>
          </p:nvSpPr>
          <p:spPr>
            <a:xfrm>
              <a:off x="5358965" y="4596877"/>
              <a:ext cx="23115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3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DA514C56-3FC3-DF5F-4DC4-CBCDBFA482E4}"/>
                </a:ext>
              </a:extLst>
            </p:cNvPr>
            <p:cNvSpPr txBox="1"/>
            <p:nvPr/>
          </p:nvSpPr>
          <p:spPr>
            <a:xfrm>
              <a:off x="8743685" y="4605840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08313B8F-FFDA-5D0B-7258-A87A405CB333}"/>
                </a:ext>
              </a:extLst>
            </p:cNvPr>
            <p:cNvSpPr txBox="1"/>
            <p:nvPr/>
          </p:nvSpPr>
          <p:spPr>
            <a:xfrm>
              <a:off x="8673037" y="4597535"/>
              <a:ext cx="23115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3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54670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4E5A9BD-6A57-F0B0-B00A-9B570AA3FDC0}"/>
              </a:ext>
            </a:extLst>
          </p:cNvPr>
          <p:cNvSpPr txBox="1"/>
          <p:nvPr/>
        </p:nvSpPr>
        <p:spPr>
          <a:xfrm>
            <a:off x="1312551" y="1159270"/>
            <a:ext cx="956689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Figure S5: Reactivity after </a:t>
            </a:r>
            <a:r>
              <a:rPr lang="en-US" b="1" dirty="0" err="1"/>
              <a:t>hmOEG-iNs</a:t>
            </a:r>
            <a:r>
              <a:rPr lang="en-US" b="1" dirty="0"/>
              <a:t> transplantation into the brain of NOD-SCID mice. </a:t>
            </a:r>
            <a:r>
              <a:rPr lang="en-US" dirty="0"/>
              <a:t>(A) Intense </a:t>
            </a:r>
            <a:r>
              <a:rPr lang="en-US" dirty="0" err="1"/>
              <a:t>astroglial</a:t>
            </a:r>
            <a:r>
              <a:rPr lang="en-US" dirty="0"/>
              <a:t> reactivity at the injection site revealed by immunostaining with the astrocytic marker GFAP (red). (B) Microglia localization at the injury site showed by immunostaining with Iba-1 microglial marker (red). GFP staining (green) identifies </a:t>
            </a:r>
            <a:r>
              <a:rPr lang="en-US" dirty="0" err="1"/>
              <a:t>hmOEG</a:t>
            </a:r>
            <a:r>
              <a:rPr lang="en-US" dirty="0"/>
              <a:t> cells. (C) Colocalization of GFP and Iba-1 staining (arrowheads) suggesting phagocytosis of </a:t>
            </a:r>
            <a:r>
              <a:rPr lang="en-US" dirty="0" err="1"/>
              <a:t>hmOEG</a:t>
            </a:r>
            <a:r>
              <a:rPr lang="en-US" dirty="0"/>
              <a:t> by microglia. Nuclei were stained with DAPI (blue). Scale bar: 75 µm (A) and 25 µm (B,C). </a:t>
            </a:r>
          </a:p>
        </p:txBody>
      </p:sp>
    </p:spTree>
    <p:extLst>
      <p:ext uri="{BB962C8B-B14F-4D97-AF65-F5344CB8AC3E}">
        <p14:creationId xmlns:p14="http://schemas.microsoft.com/office/powerpoint/2010/main" val="34109587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9</TotalTime>
  <Words>115</Words>
  <Application>Microsoft Office PowerPoint</Application>
  <PresentationFormat>Panorámica</PresentationFormat>
  <Paragraphs>10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Moreno Flores</dc:creator>
  <cp:lastModifiedBy>Javier Sierra Isturiz</cp:lastModifiedBy>
  <cp:revision>12</cp:revision>
  <dcterms:created xsi:type="dcterms:W3CDTF">2023-09-05T16:05:20Z</dcterms:created>
  <dcterms:modified xsi:type="dcterms:W3CDTF">2024-06-10T16:59:28Z</dcterms:modified>
</cp:coreProperties>
</file>